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CC1DA1-6F5E-47E1-880D-9D6883E82D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84150-6028-4DF2-A61D-C272383D11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89A67-9CE4-46C8-9F00-9C377FD2A3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4EE9D-A0B6-43D0-99F8-264B5EFA7E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B9FC8-7603-4D42-84BA-439636DA92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C844B2-3BBF-4F26-8B1B-14D59BEB1D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ADDD82-7D54-4E7F-8282-7CCDED9A14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4AD93-F793-4551-97AA-65D2996A83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534576-0959-4839-A181-B6AC32D928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25FFEA-3F89-47F3-929C-DE84B78A5E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1BBF1-81C1-4F29-BD06-CAA25D75E9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3E767-7EB2-4DFC-8655-FC529C7C45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0BB7A7-6273-4CB3-8AFB-2C09B65635D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267080" y="3170160"/>
          <a:ext cx="609840" cy="517680"/>
        </p:xfrm>
        <a:graphic>
          <a:graphicData uri="http://schemas.openxmlformats.org/drawingml/2006/table">
            <a:tbl>
              <a:tblPr/>
              <a:tblGrid>
                <a:gridCol w="609840"/>
              </a:tblGrid>
              <a:tr h="51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4267080" y="3170160"/>
          <a:ext cx="609840" cy="517680"/>
        </p:xfrm>
        <a:graphic>
          <a:graphicData uri="http://schemas.openxmlformats.org/drawingml/2006/table">
            <a:tbl>
              <a:tblPr/>
              <a:tblGrid>
                <a:gridCol w="609840"/>
              </a:tblGrid>
              <a:tr h="5176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3" name="Object 31"/>
          <p:cNvGraphicFramePr/>
          <p:nvPr/>
        </p:nvGraphicFramePr>
        <p:xfrm>
          <a:off x="2676600" y="1143000"/>
          <a:ext cx="3647880" cy="289548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4" name="Object 3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676600" y="1143000"/>
                    <a:ext cx="3647880" cy="2895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Rectangle 34"/>
          <p:cNvSpPr/>
          <p:nvPr/>
        </p:nvSpPr>
        <p:spPr>
          <a:xfrm>
            <a:off x="6095880" y="3124080"/>
            <a:ext cx="152640" cy="152640"/>
          </a:xfrm>
          <a:prstGeom prst="rect">
            <a:avLst/>
          </a:prstGeom>
          <a:solidFill>
            <a:srgbClr val="ff00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35"/>
          <p:cNvSpPr/>
          <p:nvPr/>
        </p:nvSpPr>
        <p:spPr>
          <a:xfrm>
            <a:off x="6095880" y="2895480"/>
            <a:ext cx="152640" cy="152640"/>
          </a:xfrm>
          <a:prstGeom prst="rect">
            <a:avLst/>
          </a:prstGeom>
          <a:solidFill>
            <a:srgbClr val="ffff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36"/>
          <p:cNvSpPr/>
          <p:nvPr/>
        </p:nvSpPr>
        <p:spPr>
          <a:xfrm>
            <a:off x="6095880" y="2666880"/>
            <a:ext cx="152640" cy="152640"/>
          </a:xfrm>
          <a:prstGeom prst="rect">
            <a:avLst/>
          </a:prstGeom>
          <a:solidFill>
            <a:srgbClr val="ff99cc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37"/>
          <p:cNvSpPr/>
          <p:nvPr/>
        </p:nvSpPr>
        <p:spPr>
          <a:xfrm>
            <a:off x="6095880" y="2438280"/>
            <a:ext cx="152640" cy="152640"/>
          </a:xfrm>
          <a:prstGeom prst="rect">
            <a:avLst/>
          </a:prstGeom>
          <a:solidFill>
            <a:srgbClr val="cc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38"/>
          <p:cNvSpPr/>
          <p:nvPr/>
        </p:nvSpPr>
        <p:spPr>
          <a:xfrm>
            <a:off x="6095880" y="2209680"/>
            <a:ext cx="152640" cy="152640"/>
          </a:xfrm>
          <a:prstGeom prst="rect">
            <a:avLst/>
          </a:prstGeom>
          <a:solidFill>
            <a:srgbClr val="993300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39"/>
          <p:cNvSpPr/>
          <p:nvPr/>
        </p:nvSpPr>
        <p:spPr>
          <a:xfrm>
            <a:off x="3200400" y="3733920"/>
            <a:ext cx="2743200" cy="228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40"/>
          <p:cNvSpPr/>
          <p:nvPr/>
        </p:nvSpPr>
        <p:spPr>
          <a:xfrm>
            <a:off x="6250680" y="3089160"/>
            <a:ext cx="1206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cramble shR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42"/>
          <p:cNvSpPr/>
          <p:nvPr/>
        </p:nvSpPr>
        <p:spPr>
          <a:xfrm>
            <a:off x="6250680" y="2174760"/>
            <a:ext cx="193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CSL5 shRNA clone H45548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43"/>
          <p:cNvSpPr/>
          <p:nvPr/>
        </p:nvSpPr>
        <p:spPr>
          <a:xfrm>
            <a:off x="6250680" y="2394000"/>
            <a:ext cx="193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CSL5 shRNA clone H45549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4"/>
          <p:cNvSpPr/>
          <p:nvPr/>
        </p:nvSpPr>
        <p:spPr>
          <a:xfrm>
            <a:off x="6250680" y="2631960"/>
            <a:ext cx="193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CSL5 shRNA clone H45550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5"/>
          <p:cNvSpPr/>
          <p:nvPr/>
        </p:nvSpPr>
        <p:spPr>
          <a:xfrm>
            <a:off x="6250680" y="2851200"/>
            <a:ext cx="193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CSL5 shRNA clone H45551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46"/>
          <p:cNvSpPr/>
          <p:nvPr/>
        </p:nvSpPr>
        <p:spPr>
          <a:xfrm rot="16200000">
            <a:off x="1513800" y="2518920"/>
            <a:ext cx="215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ACSL5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relative to </a:t>
            </a:r>
            <a:r>
              <a:rPr b="0" i="1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47"/>
          <p:cNvSpPr/>
          <p:nvPr/>
        </p:nvSpPr>
        <p:spPr>
          <a:xfrm>
            <a:off x="2849400" y="3048120"/>
            <a:ext cx="32076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8"/>
          <p:cNvSpPr/>
          <p:nvPr/>
        </p:nvSpPr>
        <p:spPr>
          <a:xfrm>
            <a:off x="2819520" y="2286000"/>
            <a:ext cx="32040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49"/>
          <p:cNvSpPr/>
          <p:nvPr/>
        </p:nvSpPr>
        <p:spPr>
          <a:xfrm>
            <a:off x="2819520" y="1600200"/>
            <a:ext cx="32040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50"/>
          <p:cNvSpPr/>
          <p:nvPr/>
        </p:nvSpPr>
        <p:spPr>
          <a:xfrm>
            <a:off x="4191120" y="1219320"/>
            <a:ext cx="761760" cy="457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52"/>
          <p:cNvSpPr/>
          <p:nvPr/>
        </p:nvSpPr>
        <p:spPr>
          <a:xfrm>
            <a:off x="4047120" y="1371600"/>
            <a:ext cx="929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CSL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1"/>
          <p:cNvSpPr/>
          <p:nvPr/>
        </p:nvSpPr>
        <p:spPr>
          <a:xfrm>
            <a:off x="2438280" y="1371600"/>
            <a:ext cx="5715000" cy="243828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07T22:54:11Z</dcterms:created>
  <dc:creator>duyen dang</dc:creator>
  <dc:description/>
  <dc:language>en-US</dc:language>
  <cp:lastModifiedBy>danglh</cp:lastModifiedBy>
  <dcterms:modified xsi:type="dcterms:W3CDTF">2010-11-11T16:17:40Z</dcterms:modified>
  <cp:revision>12</cp:revision>
  <dc:subject/>
  <dc:title>Slide 1</dc:title>
</cp:coreProperties>
</file>